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1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57" d="100"/>
          <a:sy n="57" d="100"/>
        </p:scale>
        <p:origin x="102" y="13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229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273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36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07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2643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534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17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038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6290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517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6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CDBC9-53DC-4213-B545-B1586C9849DE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95BFF-CB1D-4298-83C0-CBB36D897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659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image" Target="../media/image9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7.png"/><Relationship Id="rId18" Type="http://schemas.openxmlformats.org/officeDocument/2006/relationships/image" Target="../media/image21.png"/><Relationship Id="rId3" Type="http://schemas.microsoft.com/office/2007/relationships/hdphoto" Target="../media/hdphoto8.wdp"/><Relationship Id="rId7" Type="http://schemas.microsoft.com/office/2007/relationships/hdphoto" Target="../media/hdphoto10.wdp"/><Relationship Id="rId12" Type="http://schemas.microsoft.com/office/2007/relationships/hdphoto" Target="../media/hdphoto11.wdp"/><Relationship Id="rId17" Type="http://schemas.openxmlformats.org/officeDocument/2006/relationships/image" Target="../media/image20.png"/><Relationship Id="rId2" Type="http://schemas.openxmlformats.org/officeDocument/2006/relationships/image" Target="../media/image10.png"/><Relationship Id="rId16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11" Type="http://schemas.openxmlformats.org/officeDocument/2006/relationships/image" Target="../media/image16.png"/><Relationship Id="rId5" Type="http://schemas.microsoft.com/office/2007/relationships/hdphoto" Target="../media/hdphoto9.wdp"/><Relationship Id="rId15" Type="http://schemas.microsoft.com/office/2007/relationships/hdphoto" Target="../media/hdphoto12.wdp"/><Relationship Id="rId10" Type="http://schemas.openxmlformats.org/officeDocument/2006/relationships/image" Target="../media/image15.png"/><Relationship Id="rId19" Type="http://schemas.openxmlformats.org/officeDocument/2006/relationships/image" Target="../media/image22.png"/><Relationship Id="rId4" Type="http://schemas.openxmlformats.org/officeDocument/2006/relationships/image" Target="../media/image11.png"/><Relationship Id="rId9" Type="http://schemas.openxmlformats.org/officeDocument/2006/relationships/image" Target="../media/image14.png"/><Relationship Id="rId14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4.png"/><Relationship Id="rId7" Type="http://schemas.microsoft.com/office/2007/relationships/hdphoto" Target="../media/hdphoto13.wdp"/><Relationship Id="rId12" Type="http://schemas.microsoft.com/office/2007/relationships/hdphoto" Target="../media/hdphoto15.wdp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30.png"/><Relationship Id="rId5" Type="http://schemas.openxmlformats.org/officeDocument/2006/relationships/image" Target="../media/image26.png"/><Relationship Id="rId10" Type="http://schemas.openxmlformats.org/officeDocument/2006/relationships/image" Target="../media/image29.png"/><Relationship Id="rId4" Type="http://schemas.openxmlformats.org/officeDocument/2006/relationships/image" Target="../media/image25.png"/><Relationship Id="rId9" Type="http://schemas.microsoft.com/office/2007/relationships/hdphoto" Target="../media/hdphoto14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6.wdp"/><Relationship Id="rId7" Type="http://schemas.openxmlformats.org/officeDocument/2006/relationships/image" Target="../media/image42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5857159" y="673883"/>
            <a:ext cx="6057074" cy="5006111"/>
            <a:chOff x="276491" y="762677"/>
            <a:chExt cx="6057074" cy="500611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77399" y="2023701"/>
              <a:ext cx="1575910" cy="513907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711424" y="4350731"/>
              <a:ext cx="1575910" cy="682533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711424" y="1782945"/>
              <a:ext cx="1575910" cy="1124172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711424" y="3015520"/>
              <a:ext cx="1575910" cy="562086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701515" y="3677023"/>
              <a:ext cx="1575910" cy="562086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50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1711424" y="5174583"/>
              <a:ext cx="1575910" cy="594205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981300" y="793376"/>
              <a:ext cx="9653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/>
                <a:t>Fig 1D</a:t>
              </a:r>
              <a:endParaRPr lang="en-US" sz="24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288028" y="1471589"/>
              <a:ext cx="1911514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Dox:       -      +     -     +</a:t>
              </a:r>
              <a:endParaRPr lang="en-US" b="1" dirty="0"/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2034571" y="1471589"/>
              <a:ext cx="454898" cy="0"/>
            </a:xfrm>
            <a:prstGeom prst="line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2663492" y="1471589"/>
              <a:ext cx="454898" cy="0"/>
            </a:xfrm>
            <a:prstGeom prst="line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5143918" y="1715280"/>
              <a:ext cx="454898" cy="0"/>
            </a:xfrm>
            <a:prstGeom prst="line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4276890" y="1715280"/>
              <a:ext cx="454898" cy="0"/>
            </a:xfrm>
            <a:prstGeom prst="line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 rot="19159450">
              <a:off x="1915647" y="762677"/>
              <a:ext cx="14414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ONS-shSTAT3</a:t>
              </a:r>
              <a:endParaRPr lang="en-US" b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9038857">
              <a:off x="2629108" y="762677"/>
              <a:ext cx="13164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HD-shSTAT3</a:t>
              </a:r>
              <a:endParaRPr lang="en-US" b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93692" y="2627921"/>
              <a:ext cx="829073" cy="17543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STAT3</a:t>
              </a:r>
            </a:p>
            <a:p>
              <a:endParaRPr lang="en-US" b="1" dirty="0" smtClean="0"/>
            </a:p>
            <a:p>
              <a:r>
                <a:rPr lang="en-US" b="1" dirty="0" smtClean="0"/>
                <a:t>MYC</a:t>
              </a:r>
            </a:p>
            <a:p>
              <a:endParaRPr lang="en-US" b="1" dirty="0"/>
            </a:p>
            <a:p>
              <a:r>
                <a:rPr lang="en-US" b="1" dirty="0" smtClean="0"/>
                <a:t>BCL-XL</a:t>
              </a:r>
              <a:endParaRPr lang="en-US" b="1" dirty="0"/>
            </a:p>
            <a:p>
              <a:endParaRPr lang="en-US" b="1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9159450">
              <a:off x="5078336" y="1113177"/>
              <a:ext cx="1255229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ONS-shSTAT3</a:t>
              </a:r>
              <a:endParaRPr lang="en-US" b="1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9038857">
              <a:off x="4226662" y="1136621"/>
              <a:ext cx="1146351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D-shSTAT3</a:t>
              </a:r>
              <a:endParaRPr lang="en-US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670887" y="2151122"/>
              <a:ext cx="615861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BRD4</a:t>
              </a:r>
              <a:endParaRPr lang="en-US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69703" y="4638763"/>
              <a:ext cx="731719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CCND1</a:t>
              </a:r>
              <a:endParaRPr lang="en-US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76491" y="5268035"/>
              <a:ext cx="14096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 smtClean="0"/>
                <a:t>Cyclophilin</a:t>
              </a:r>
              <a:r>
                <a:rPr lang="en-US" b="1" dirty="0" smtClean="0"/>
                <a:t> B</a:t>
              </a:r>
              <a:endParaRPr lang="en-US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48582" y="1712346"/>
              <a:ext cx="2060760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Dox:       -      +        -     +</a:t>
              </a:r>
              <a:endParaRPr lang="en-US" b="1" dirty="0"/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726444" y="575462"/>
            <a:ext cx="4260752" cy="6025534"/>
            <a:chOff x="6946166" y="586043"/>
            <a:chExt cx="4260752" cy="6025534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14"/>
            <a:srcRect l="33305" t="10065" r="34439" b="52398"/>
            <a:stretch/>
          </p:blipFill>
          <p:spPr>
            <a:xfrm>
              <a:off x="8820298" y="4239109"/>
              <a:ext cx="2085721" cy="2372468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l="14698" r="56256" b="77353"/>
            <a:stretch/>
          </p:blipFill>
          <p:spPr>
            <a:xfrm>
              <a:off x="8915484" y="1815595"/>
              <a:ext cx="1886857" cy="1471217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17"/>
            <a:srcRect b="45382"/>
            <a:stretch/>
          </p:blipFill>
          <p:spPr>
            <a:xfrm>
              <a:off x="8820298" y="3470810"/>
              <a:ext cx="2085721" cy="608672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27" name="TextBox 26"/>
            <p:cNvSpPr txBox="1"/>
            <p:nvPr/>
          </p:nvSpPr>
          <p:spPr>
            <a:xfrm>
              <a:off x="7597689" y="837781"/>
              <a:ext cx="94448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/>
                <a:t>Fig 1B</a:t>
              </a:r>
              <a:endParaRPr lang="en-US" sz="24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 rot="19038857">
              <a:off x="9051463" y="620785"/>
              <a:ext cx="1146351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D-shSTAT3</a:t>
              </a:r>
              <a:endParaRPr lang="en-US" b="1" dirty="0"/>
            </a:p>
          </p:txBody>
        </p:sp>
        <p:sp>
          <p:nvSpPr>
            <p:cNvPr id="29" name="TextBox 28"/>
            <p:cNvSpPr txBox="1"/>
            <p:nvPr/>
          </p:nvSpPr>
          <p:spPr>
            <a:xfrm rot="19159450">
              <a:off x="9951689" y="586043"/>
              <a:ext cx="1255229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ONS-shSTAT3</a:t>
              </a:r>
              <a:endParaRPr lang="en-US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265657" y="1420663"/>
              <a:ext cx="23136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Dox:       -      +      -     +</a:t>
              </a:r>
              <a:endParaRPr lang="en-US" b="1" dirty="0"/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10037925" y="1292299"/>
              <a:ext cx="454898" cy="0"/>
            </a:xfrm>
            <a:prstGeom prst="line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9169741" y="1292299"/>
              <a:ext cx="454898" cy="0"/>
            </a:xfrm>
            <a:prstGeom prst="line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7575679" y="2646188"/>
              <a:ext cx="7393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STAT3</a:t>
              </a:r>
              <a:endParaRPr lang="en-US" b="1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007527" y="3646449"/>
              <a:ext cx="14046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pY705-STAT3</a:t>
              </a:r>
              <a:endParaRPr lang="en-US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946166" y="4944461"/>
              <a:ext cx="16434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 smtClean="0"/>
                <a:t>pSer</a:t>
              </a:r>
              <a:r>
                <a:rPr lang="en-US" b="1" dirty="0" smtClean="0"/>
                <a:t> 727-STAT3</a:t>
              </a:r>
              <a:endParaRPr lang="en-US" b="1" dirty="0"/>
            </a:p>
          </p:txBody>
        </p:sp>
        <p:cxnSp>
          <p:nvCxnSpPr>
            <p:cNvPr id="37" name="Straight Arrow Connector 36"/>
            <p:cNvCxnSpPr/>
            <p:nvPr/>
          </p:nvCxnSpPr>
          <p:spPr>
            <a:xfrm>
              <a:off x="8538633" y="5115941"/>
              <a:ext cx="559127" cy="4873"/>
            </a:xfrm>
            <a:prstGeom prst="straightConnector1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/>
            <p:cNvCxnSpPr/>
            <p:nvPr/>
          </p:nvCxnSpPr>
          <p:spPr>
            <a:xfrm>
              <a:off x="8344617" y="3833552"/>
              <a:ext cx="559127" cy="4873"/>
            </a:xfrm>
            <a:prstGeom prst="straightConnector1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>
              <a:off x="8259069" y="2826454"/>
              <a:ext cx="559127" cy="4873"/>
            </a:xfrm>
            <a:prstGeom prst="straightConnector1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Box 35"/>
          <p:cNvSpPr txBox="1"/>
          <p:nvPr/>
        </p:nvSpPr>
        <p:spPr>
          <a:xfrm>
            <a:off x="1135970" y="6039916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GAPDH</a:t>
            </a:r>
            <a:endParaRPr lang="en-US" b="1" dirty="0"/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2039346" y="6265983"/>
            <a:ext cx="559127" cy="487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919381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358265" y="631329"/>
            <a:ext cx="6107939" cy="5079176"/>
            <a:chOff x="1348865" y="36969"/>
            <a:chExt cx="6107939" cy="5079176"/>
          </a:xfrm>
        </p:grpSpPr>
        <p:grpSp>
          <p:nvGrpSpPr>
            <p:cNvPr id="27" name="Group 26"/>
            <p:cNvGrpSpPr/>
            <p:nvPr/>
          </p:nvGrpSpPr>
          <p:grpSpPr>
            <a:xfrm>
              <a:off x="2239574" y="470992"/>
              <a:ext cx="1982457" cy="4645153"/>
              <a:chOff x="2239574" y="470992"/>
              <a:chExt cx="1982457" cy="4645153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038928" y="1443264"/>
                <a:ext cx="685800" cy="952500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021224" y="2617041"/>
                <a:ext cx="703503" cy="695325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rcRect l="8486" t="1" r="13060" b="18268"/>
              <a:stretch/>
            </p:blipFill>
            <p:spPr>
              <a:xfrm>
                <a:off x="2908844" y="4687974"/>
                <a:ext cx="904876" cy="428171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8"/>
              <a:srcRect t="36750"/>
              <a:stretch/>
            </p:blipFill>
            <p:spPr>
              <a:xfrm>
                <a:off x="2908845" y="3398566"/>
                <a:ext cx="904875" cy="1147941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sp>
            <p:nvSpPr>
              <p:cNvPr id="12" name="TextBox 11"/>
              <p:cNvSpPr txBox="1"/>
              <p:nvPr/>
            </p:nvSpPr>
            <p:spPr>
              <a:xfrm rot="19038857">
                <a:off x="3075680" y="470992"/>
                <a:ext cx="1146351" cy="3113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HD-shSTAT3</a:t>
                </a:r>
                <a:endParaRPr lang="en-US" b="1" dirty="0"/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>
                <a:off x="3133833" y="1096806"/>
                <a:ext cx="454898" cy="0"/>
              </a:xfrm>
              <a:prstGeom prst="line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2239574" y="1060634"/>
                <a:ext cx="15987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Dox:       -      +  </a:t>
                </a:r>
                <a:endParaRPr lang="en-US" b="1" dirty="0"/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4115609" y="1221987"/>
              <a:ext cx="3341195" cy="3827568"/>
              <a:chOff x="8015569" y="665779"/>
              <a:chExt cx="3341195" cy="3827568"/>
            </a:xfrm>
          </p:grpSpPr>
          <p:cxnSp>
            <p:nvCxnSpPr>
              <p:cNvPr id="10" name="Straight Connector 9"/>
              <p:cNvCxnSpPr/>
              <p:nvPr/>
            </p:nvCxnSpPr>
            <p:spPr>
              <a:xfrm>
                <a:off x="8956204" y="1356325"/>
                <a:ext cx="454898" cy="0"/>
              </a:xfrm>
              <a:prstGeom prst="line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/>
              <p:cNvSpPr txBox="1"/>
              <p:nvPr/>
            </p:nvSpPr>
            <p:spPr>
              <a:xfrm rot="19159450">
                <a:off x="8783488" y="665779"/>
                <a:ext cx="1255229" cy="3113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ONS-shSTAT3</a:t>
                </a:r>
                <a:endParaRPr lang="en-US" b="1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8015569" y="1435758"/>
                <a:ext cx="15987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Dox:       -      +  </a:t>
                </a:r>
                <a:endParaRPr lang="en-US" b="1" dirty="0"/>
              </a:p>
            </p:txBody>
          </p:sp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9"/>
              <a:srcRect b="75033"/>
              <a:stretch/>
            </p:blipFill>
            <p:spPr>
              <a:xfrm>
                <a:off x="8709402" y="1820633"/>
                <a:ext cx="904875" cy="663488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 rotWithShape="1">
              <a:blip r:embed="rId9"/>
              <a:srcRect t="32825"/>
              <a:stretch/>
            </p:blipFill>
            <p:spPr>
              <a:xfrm>
                <a:off x="8709401" y="2708182"/>
                <a:ext cx="904875" cy="1785165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sp>
            <p:nvSpPr>
              <p:cNvPr id="2" name="TextBox 1"/>
              <p:cNvSpPr txBox="1"/>
              <p:nvPr/>
            </p:nvSpPr>
            <p:spPr>
              <a:xfrm>
                <a:off x="10076892" y="1771601"/>
                <a:ext cx="80086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err="1" smtClean="0"/>
                  <a:t>Nestin</a:t>
                </a:r>
                <a:endParaRPr lang="en-US" b="1" dirty="0"/>
              </a:p>
            </p:txBody>
          </p:sp>
          <p:sp>
            <p:nvSpPr>
              <p:cNvPr id="3" name="TextBox 2"/>
              <p:cNvSpPr txBox="1"/>
              <p:nvPr/>
            </p:nvSpPr>
            <p:spPr>
              <a:xfrm>
                <a:off x="10066099" y="3007600"/>
                <a:ext cx="10334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/>
                  <a:t>Oct3/4</a:t>
                </a:r>
                <a:endParaRPr lang="en-US" b="1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0083083" y="3273488"/>
                <a:ext cx="6353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Sox2</a:t>
                </a:r>
                <a:endParaRPr lang="en-US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0129890" y="3864817"/>
                <a:ext cx="122687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err="1" smtClean="0"/>
                  <a:t>Cyclophilin</a:t>
                </a:r>
                <a:endParaRPr lang="en-US" b="1" dirty="0"/>
              </a:p>
            </p:txBody>
          </p:sp>
          <p:cxnSp>
            <p:nvCxnSpPr>
              <p:cNvPr id="21" name="Straight Arrow Connector 20"/>
              <p:cNvCxnSpPr/>
              <p:nvPr/>
            </p:nvCxnSpPr>
            <p:spPr>
              <a:xfrm flipH="1">
                <a:off x="9614277" y="1974819"/>
                <a:ext cx="475743" cy="9298"/>
              </a:xfrm>
              <a:prstGeom prst="straightConnector1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Arrow Connector 22"/>
              <p:cNvCxnSpPr/>
              <p:nvPr/>
            </p:nvCxnSpPr>
            <p:spPr>
              <a:xfrm flipH="1">
                <a:off x="9614277" y="3185580"/>
                <a:ext cx="475743" cy="9298"/>
              </a:xfrm>
              <a:prstGeom prst="straightConnector1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Arrow Connector 23"/>
              <p:cNvCxnSpPr/>
              <p:nvPr/>
            </p:nvCxnSpPr>
            <p:spPr>
              <a:xfrm flipH="1">
                <a:off x="9614277" y="3453505"/>
                <a:ext cx="475743" cy="9298"/>
              </a:xfrm>
              <a:prstGeom prst="straightConnector1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H="1">
                <a:off x="9635310" y="4049483"/>
                <a:ext cx="475743" cy="9298"/>
              </a:xfrm>
              <a:prstGeom prst="straightConnector1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" name="TextBox 27"/>
            <p:cNvSpPr txBox="1"/>
            <p:nvPr/>
          </p:nvSpPr>
          <p:spPr>
            <a:xfrm>
              <a:off x="1348865" y="36969"/>
              <a:ext cx="174919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/>
                <a:t>Fig 3C and D</a:t>
              </a:r>
              <a:endParaRPr lang="en-US" sz="24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087880" y="1991966"/>
              <a:ext cx="801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CD133</a:t>
              </a:r>
              <a:endParaRPr lang="en-US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083060" y="2670997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Oct 3/4</a:t>
              </a:r>
              <a:endParaRPr lang="en-US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284634" y="3635277"/>
              <a:ext cx="6353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Sox2</a:t>
              </a:r>
              <a:endParaRPr lang="en-US" b="1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702807" y="4703523"/>
              <a:ext cx="12268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 smtClean="0"/>
                <a:t>Cyclophilin</a:t>
              </a:r>
              <a:endParaRPr lang="en-US" b="1" dirty="0"/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7447525" y="1870820"/>
            <a:ext cx="3775776" cy="3824293"/>
            <a:chOff x="1411485" y="750086"/>
            <a:chExt cx="3775776" cy="3824293"/>
          </a:xfrm>
        </p:grpSpPr>
        <p:grpSp>
          <p:nvGrpSpPr>
            <p:cNvPr id="35" name="Group 34"/>
            <p:cNvGrpSpPr/>
            <p:nvPr/>
          </p:nvGrpSpPr>
          <p:grpSpPr>
            <a:xfrm>
              <a:off x="2015489" y="1706164"/>
              <a:ext cx="1038225" cy="2759869"/>
              <a:chOff x="3371849" y="545306"/>
              <a:chExt cx="1038225" cy="2759869"/>
            </a:xfrm>
          </p:grpSpPr>
          <p:pic>
            <p:nvPicPr>
              <p:cNvPr id="51" name="Picture 50"/>
              <p:cNvPicPr>
                <a:picLocks noChangeAspect="1"/>
              </p:cNvPicPr>
              <p:nvPr/>
            </p:nvPicPr>
            <p:blipFill rotWithShape="1">
              <a:blip r:embed="rId10"/>
              <a:srcRect r="14844"/>
              <a:stretch/>
            </p:blipFill>
            <p:spPr>
              <a:xfrm>
                <a:off x="3371849" y="1338262"/>
                <a:ext cx="1038225" cy="603647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52" name="Picture 51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rcRect l="8220" t="-1" r="6615" b="-8257"/>
              <a:stretch/>
            </p:blipFill>
            <p:spPr>
              <a:xfrm>
                <a:off x="3371849" y="2094840"/>
                <a:ext cx="978171" cy="552844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53" name="Picture 52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529012" y="545306"/>
                <a:ext cx="742950" cy="666750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54" name="Picture 53"/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529012" y="2867025"/>
                <a:ext cx="800100" cy="438150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</p:grpSp>
        <p:grpSp>
          <p:nvGrpSpPr>
            <p:cNvPr id="36" name="Group 35"/>
            <p:cNvGrpSpPr/>
            <p:nvPr/>
          </p:nvGrpSpPr>
          <p:grpSpPr>
            <a:xfrm>
              <a:off x="4001452" y="1719260"/>
              <a:ext cx="819150" cy="2855119"/>
              <a:chOff x="5129212" y="588168"/>
              <a:chExt cx="819150" cy="2855119"/>
            </a:xfrm>
          </p:grpSpPr>
          <p:pic>
            <p:nvPicPr>
              <p:cNvPr id="47" name="Picture 46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5138737" y="1304925"/>
                <a:ext cx="809625" cy="590550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48" name="Picture 47"/>
              <p:cNvPicPr>
                <a:picLocks noChangeAspect="1"/>
              </p:cNvPicPr>
              <p:nvPr/>
            </p:nvPicPr>
            <p:blipFill rotWithShape="1">
              <a:blip r:embed="rId17"/>
              <a:srcRect l="20816" r="7617"/>
              <a:stretch/>
            </p:blipFill>
            <p:spPr>
              <a:xfrm>
                <a:off x="5129212" y="2024062"/>
                <a:ext cx="819150" cy="656337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49" name="Picture 48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5129212" y="588168"/>
                <a:ext cx="771525" cy="581025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50" name="Picture 49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5162549" y="2805112"/>
                <a:ext cx="742950" cy="638175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</p:grpSp>
        <p:sp>
          <p:nvSpPr>
            <p:cNvPr id="37" name="TextBox 36"/>
            <p:cNvSpPr txBox="1"/>
            <p:nvPr/>
          </p:nvSpPr>
          <p:spPr>
            <a:xfrm rot="19038857">
              <a:off x="2154429" y="750086"/>
              <a:ext cx="1146351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D-shSTAT3</a:t>
              </a:r>
              <a:endParaRPr lang="en-US" b="1" dirty="0"/>
            </a:p>
          </p:txBody>
        </p:sp>
        <p:sp>
          <p:nvSpPr>
            <p:cNvPr id="38" name="TextBox 37"/>
            <p:cNvSpPr txBox="1"/>
            <p:nvPr/>
          </p:nvSpPr>
          <p:spPr>
            <a:xfrm rot="19159450">
              <a:off x="3932032" y="750086"/>
              <a:ext cx="1255229" cy="3113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ONS-shSTAT3</a:t>
              </a:r>
              <a:endParaRPr lang="en-US" b="1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226999" y="1428968"/>
              <a:ext cx="15987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Dox:       -      +  </a:t>
              </a:r>
              <a:endParaRPr lang="en-US" b="1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411485" y="1372816"/>
              <a:ext cx="15987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Dox:       -      +  </a:t>
              </a:r>
              <a:endParaRPr lang="en-US" b="1" dirty="0"/>
            </a:p>
          </p:txBody>
        </p:sp>
        <p:cxnSp>
          <p:nvCxnSpPr>
            <p:cNvPr id="41" name="Straight Connector 40"/>
            <p:cNvCxnSpPr/>
            <p:nvPr/>
          </p:nvCxnSpPr>
          <p:spPr>
            <a:xfrm>
              <a:off x="2345253" y="1446813"/>
              <a:ext cx="454898" cy="0"/>
            </a:xfrm>
            <a:prstGeom prst="line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4104748" y="1446813"/>
              <a:ext cx="454898" cy="0"/>
            </a:xfrm>
            <a:prstGeom prst="line">
              <a:avLst/>
            </a:prstGeom>
            <a:ln w="28575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3094869" y="1825106"/>
              <a:ext cx="7393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STAT3</a:t>
              </a:r>
              <a:endParaRPr lang="en-US" b="1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022280" y="2626396"/>
              <a:ext cx="1043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3K27Ac</a:t>
              </a:r>
              <a:endParaRPr lang="en-US" b="1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254483" y="3227368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3</a:t>
              </a:r>
              <a:endParaRPr lang="en-US" b="1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094869" y="4020086"/>
              <a:ext cx="8867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GAPDH</a:t>
              </a:r>
              <a:endParaRPr lang="en-US" b="1" dirty="0"/>
            </a:p>
          </p:txBody>
        </p:sp>
      </p:grpSp>
      <p:sp>
        <p:nvSpPr>
          <p:cNvPr id="55" name="TextBox 54"/>
          <p:cNvSpPr txBox="1"/>
          <p:nvPr/>
        </p:nvSpPr>
        <p:spPr>
          <a:xfrm>
            <a:off x="7186947" y="862161"/>
            <a:ext cx="9653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Fig 4D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9639435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6687530" y="1024091"/>
            <a:ext cx="1924050" cy="2309224"/>
            <a:chOff x="1776946" y="1067286"/>
            <a:chExt cx="1924050" cy="2309224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76946" y="1497275"/>
              <a:ext cx="1924050" cy="1038225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76947" y="2595460"/>
              <a:ext cx="1909060" cy="781050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11" name="TextBox 10"/>
            <p:cNvSpPr txBox="1"/>
            <p:nvPr/>
          </p:nvSpPr>
          <p:spPr>
            <a:xfrm>
              <a:off x="2117495" y="1067286"/>
              <a:ext cx="14414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ONS-shSTAT3</a:t>
              </a:r>
              <a:endParaRPr lang="en-US" b="1" dirty="0"/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1695125" y="1147596"/>
            <a:ext cx="2038350" cy="2381752"/>
            <a:chOff x="1615344" y="3504857"/>
            <a:chExt cx="2038350" cy="2381752"/>
          </a:xfrm>
        </p:grpSpPr>
        <p:grpSp>
          <p:nvGrpSpPr>
            <p:cNvPr id="34" name="Group 33"/>
            <p:cNvGrpSpPr/>
            <p:nvPr/>
          </p:nvGrpSpPr>
          <p:grpSpPr>
            <a:xfrm>
              <a:off x="1615344" y="3902772"/>
              <a:ext cx="2038350" cy="1983837"/>
              <a:chOff x="1615344" y="3902772"/>
              <a:chExt cx="2038350" cy="1983837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615344" y="4915059"/>
                <a:ext cx="2038350" cy="971550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739169" y="3902772"/>
                <a:ext cx="1914525" cy="952500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</p:grpSp>
        <p:sp>
          <p:nvSpPr>
            <p:cNvPr id="14" name="TextBox 13"/>
            <p:cNvSpPr txBox="1"/>
            <p:nvPr/>
          </p:nvSpPr>
          <p:spPr>
            <a:xfrm>
              <a:off x="2130687" y="3504857"/>
              <a:ext cx="13164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D-shSTAT3</a:t>
              </a:r>
              <a:endParaRPr lang="en-US" b="1" dirty="0"/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1920887" y="4120887"/>
            <a:ext cx="1606032" cy="2275570"/>
            <a:chOff x="7514899" y="4028597"/>
            <a:chExt cx="1606032" cy="2275570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610439" y="4521234"/>
              <a:ext cx="1476375" cy="552450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27" name="TextBox 26"/>
            <p:cNvSpPr txBox="1"/>
            <p:nvPr/>
          </p:nvSpPr>
          <p:spPr>
            <a:xfrm>
              <a:off x="7784635" y="4028597"/>
              <a:ext cx="13164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D-shSTAT3</a:t>
              </a:r>
              <a:endParaRPr lang="en-US" b="1" dirty="0"/>
            </a:p>
          </p:txBody>
        </p:sp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25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514899" y="5275467"/>
              <a:ext cx="1606032" cy="1028700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</p:grpSp>
      <p:grpSp>
        <p:nvGrpSpPr>
          <p:cNvPr id="36" name="Group 35"/>
          <p:cNvGrpSpPr/>
          <p:nvPr/>
        </p:nvGrpSpPr>
        <p:grpSpPr>
          <a:xfrm>
            <a:off x="6375402" y="3715388"/>
            <a:ext cx="2094162" cy="2732914"/>
            <a:chOff x="7389839" y="1081249"/>
            <a:chExt cx="2094162" cy="2732914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389839" y="1486748"/>
              <a:ext cx="2085975" cy="1190625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21" name="TextBox 20"/>
            <p:cNvSpPr txBox="1"/>
            <p:nvPr/>
          </p:nvSpPr>
          <p:spPr>
            <a:xfrm>
              <a:off x="7852018" y="1081249"/>
              <a:ext cx="14414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ONS-shSTAT3</a:t>
              </a:r>
              <a:endParaRPr lang="en-US" b="1" dirty="0"/>
            </a:p>
          </p:txBody>
        </p:sp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579001" y="2775938"/>
              <a:ext cx="1905000" cy="1038225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</p:grpSp>
      <p:sp>
        <p:nvSpPr>
          <p:cNvPr id="31" name="TextBox 30"/>
          <p:cNvSpPr txBox="1"/>
          <p:nvPr/>
        </p:nvSpPr>
        <p:spPr>
          <a:xfrm>
            <a:off x="4898341" y="703563"/>
            <a:ext cx="9300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Fig.S3</a:t>
            </a:r>
            <a:endParaRPr lang="en-US" sz="2400" b="1" dirty="0"/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5828404" y="6110545"/>
            <a:ext cx="599607" cy="0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>
            <a:off x="5665153" y="4907515"/>
            <a:ext cx="599607" cy="0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5964957" y="2942790"/>
            <a:ext cx="599607" cy="0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>
            <a:off x="6053113" y="2338472"/>
            <a:ext cx="599607" cy="0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flipH="1">
            <a:off x="3768285" y="2338472"/>
            <a:ext cx="779074" cy="14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flipH="1">
            <a:off x="3864487" y="2939629"/>
            <a:ext cx="779074" cy="14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flipH="1">
            <a:off x="3603444" y="4906798"/>
            <a:ext cx="779074" cy="14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flipH="1">
            <a:off x="3575903" y="6109112"/>
            <a:ext cx="779074" cy="14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4925783" y="2182933"/>
            <a:ext cx="7393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TAT3</a:t>
            </a:r>
            <a:endParaRPr lang="en-US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4637478" y="2760620"/>
            <a:ext cx="1409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Cyclophilin</a:t>
            </a:r>
            <a:r>
              <a:rPr lang="en-US" b="1" dirty="0" smtClean="0"/>
              <a:t> B</a:t>
            </a:r>
            <a:endParaRPr lang="en-US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4412016" y="5882107"/>
            <a:ext cx="1409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Cyclophilin</a:t>
            </a:r>
            <a:r>
              <a:rPr lang="en-US" b="1" dirty="0" smtClean="0"/>
              <a:t> B</a:t>
            </a:r>
            <a:endParaRPr lang="en-US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4426673" y="4758280"/>
            <a:ext cx="1404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pY705-STAT3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1772103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2001840" y="626372"/>
            <a:ext cx="1974410" cy="2854975"/>
            <a:chOff x="3317667" y="626372"/>
            <a:chExt cx="1974410" cy="2854975"/>
          </a:xfrm>
        </p:grpSpPr>
        <p:sp>
          <p:nvSpPr>
            <p:cNvPr id="3" name="TextBox 2"/>
            <p:cNvSpPr txBox="1"/>
            <p:nvPr/>
          </p:nvSpPr>
          <p:spPr>
            <a:xfrm>
              <a:off x="3754316" y="626372"/>
              <a:ext cx="11128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D-MB03</a:t>
              </a:r>
              <a:endParaRPr lang="en-US" b="1" dirty="0"/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17667" y="995704"/>
              <a:ext cx="1971675" cy="1181100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20402" y="2243097"/>
              <a:ext cx="1971675" cy="1238250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</p:grpSp>
      <p:grpSp>
        <p:nvGrpSpPr>
          <p:cNvPr id="15" name="Group 14"/>
          <p:cNvGrpSpPr/>
          <p:nvPr/>
        </p:nvGrpSpPr>
        <p:grpSpPr>
          <a:xfrm>
            <a:off x="7555803" y="395539"/>
            <a:ext cx="1800226" cy="2844139"/>
            <a:chOff x="6685669" y="413370"/>
            <a:chExt cx="1800226" cy="2844139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85670" y="995704"/>
              <a:ext cx="1800225" cy="942975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685669" y="2466934"/>
              <a:ext cx="1800225" cy="790575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12" name="TextBox 11"/>
            <p:cNvSpPr txBox="1"/>
            <p:nvPr/>
          </p:nvSpPr>
          <p:spPr>
            <a:xfrm>
              <a:off x="7181788" y="413370"/>
              <a:ext cx="888385" cy="369332"/>
            </a:xfrm>
            <a:prstGeom prst="rect">
              <a:avLst/>
            </a:prstGeom>
            <a:noFill/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ONS 76</a:t>
              </a:r>
              <a:endParaRPr lang="en-US" b="1" dirty="0"/>
            </a:p>
          </p:txBody>
        </p:sp>
      </p:grp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6"/>
          <a:srcRect t="33652" b="5094"/>
          <a:stretch/>
        </p:blipFill>
        <p:spPr>
          <a:xfrm>
            <a:off x="4766604" y="3852472"/>
            <a:ext cx="2028825" cy="97435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7"/>
          <a:srcRect t="58766"/>
          <a:stretch/>
        </p:blipFill>
        <p:spPr>
          <a:xfrm>
            <a:off x="4766604" y="4913769"/>
            <a:ext cx="2028825" cy="691240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8"/>
          <a:srcRect b="35762"/>
          <a:stretch/>
        </p:blipFill>
        <p:spPr>
          <a:xfrm>
            <a:off x="4747554" y="5691948"/>
            <a:ext cx="2047875" cy="813786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13" name="TextBox 12"/>
          <p:cNvSpPr txBox="1"/>
          <p:nvPr/>
        </p:nvSpPr>
        <p:spPr>
          <a:xfrm>
            <a:off x="5336576" y="164707"/>
            <a:ext cx="9300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Fig.S4</a:t>
            </a:r>
            <a:endParaRPr lang="en-US" sz="2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431922" y="1491490"/>
            <a:ext cx="7393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TAT3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7791305" y="5074723"/>
            <a:ext cx="1404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pY705-STAT3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7733739" y="4295951"/>
            <a:ext cx="7393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TAT3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076207" y="2618022"/>
            <a:ext cx="1409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Cyclophilin</a:t>
            </a:r>
            <a:r>
              <a:rPr lang="en-US" b="1" dirty="0" smtClean="0"/>
              <a:t> B</a:t>
            </a:r>
            <a:endParaRPr lang="en-US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7791305" y="6008464"/>
            <a:ext cx="1409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Cyclophilin</a:t>
            </a:r>
            <a:r>
              <a:rPr lang="en-US" b="1" dirty="0" smtClean="0"/>
              <a:t> B</a:t>
            </a:r>
            <a:endParaRPr lang="en-US" b="1" dirty="0"/>
          </a:p>
        </p:txBody>
      </p:sp>
      <p:cxnSp>
        <p:nvCxnSpPr>
          <p:cNvPr id="21" name="Straight Arrow Connector 20"/>
          <p:cNvCxnSpPr/>
          <p:nvPr/>
        </p:nvCxnSpPr>
        <p:spPr>
          <a:xfrm flipH="1">
            <a:off x="4041521" y="2827973"/>
            <a:ext cx="779074" cy="14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H="1">
            <a:off x="4041521" y="1676156"/>
            <a:ext cx="779074" cy="14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flipH="1">
            <a:off x="6847149" y="4475170"/>
            <a:ext cx="779074" cy="14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H="1">
            <a:off x="6903830" y="5257483"/>
            <a:ext cx="779074" cy="14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6841810" y="6282074"/>
            <a:ext cx="779074" cy="1433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6795429" y="1706143"/>
            <a:ext cx="599607" cy="0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6652720" y="2827973"/>
            <a:ext cx="599607" cy="0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366099" y="3375222"/>
            <a:ext cx="3316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D-MB03 (</a:t>
            </a:r>
            <a:r>
              <a:rPr lang="en-US" b="1" dirty="0" err="1" smtClean="0"/>
              <a:t>shRNA</a:t>
            </a:r>
            <a:r>
              <a:rPr lang="en-US" b="1" dirty="0" smtClean="0"/>
              <a:t>-Non-</a:t>
            </a:r>
            <a:r>
              <a:rPr lang="en-US" b="1" dirty="0" err="1" smtClean="0"/>
              <a:t>targrting</a:t>
            </a:r>
            <a:r>
              <a:rPr lang="en-US" b="1" dirty="0" smtClean="0"/>
              <a:t>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5573465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957762" y="2661987"/>
            <a:ext cx="2190750" cy="1152525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76812" y="1241930"/>
            <a:ext cx="2105025" cy="1323975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48237" y="3910594"/>
            <a:ext cx="2209800" cy="581025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76812" y="4617486"/>
            <a:ext cx="2152650" cy="590550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48238" y="5273943"/>
            <a:ext cx="2209800" cy="1085850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9" name="TextBox 8"/>
          <p:cNvSpPr txBox="1"/>
          <p:nvPr/>
        </p:nvSpPr>
        <p:spPr>
          <a:xfrm>
            <a:off x="7661182" y="2227041"/>
            <a:ext cx="1404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pY705-STAT3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7768531" y="3085443"/>
            <a:ext cx="7393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TAT3</a:t>
            </a:r>
            <a:endParaRPr lang="en-US" b="1" dirty="0"/>
          </a:p>
        </p:txBody>
      </p:sp>
      <p:sp>
        <p:nvSpPr>
          <p:cNvPr id="2" name="TextBox 1"/>
          <p:cNvSpPr txBox="1"/>
          <p:nvPr/>
        </p:nvSpPr>
        <p:spPr>
          <a:xfrm>
            <a:off x="7746333" y="3886143"/>
            <a:ext cx="619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MYC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7578082" y="4731144"/>
            <a:ext cx="1487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leaved PARP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661182" y="5632202"/>
            <a:ext cx="1409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Cyclophilin</a:t>
            </a:r>
            <a:r>
              <a:rPr lang="en-US" b="1" dirty="0" smtClean="0"/>
              <a:t> B</a:t>
            </a:r>
            <a:endParaRPr lang="en-US" b="1" dirty="0"/>
          </a:p>
        </p:txBody>
      </p:sp>
      <p:cxnSp>
        <p:nvCxnSpPr>
          <p:cNvPr id="12" name="Straight Arrow Connector 11"/>
          <p:cNvCxnSpPr/>
          <p:nvPr/>
        </p:nvCxnSpPr>
        <p:spPr>
          <a:xfrm flipH="1">
            <a:off x="7156336" y="2430133"/>
            <a:ext cx="461387" cy="7881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H="1">
            <a:off x="7129452" y="4945043"/>
            <a:ext cx="461387" cy="7881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7218598" y="4062928"/>
            <a:ext cx="461387" cy="7881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H="1">
            <a:off x="7177672" y="5865088"/>
            <a:ext cx="461387" cy="7881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H="1">
            <a:off x="7218597" y="3256708"/>
            <a:ext cx="461387" cy="7881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689548" y="853272"/>
            <a:ext cx="13404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Fig. S11A</a:t>
            </a:r>
            <a:endParaRPr lang="en-US" sz="2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508775" y="489308"/>
            <a:ext cx="26116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L-6: </a:t>
            </a:r>
            <a:r>
              <a:rPr kumimoji="0" lang="en-US" sz="1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</a:t>
            </a: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    +     +    +    +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644332" y="880470"/>
            <a:ext cx="35333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P1066 (</a:t>
            </a:r>
            <a:r>
              <a:rPr kumimoji="0" lang="en-US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anose="05050102010706020507" pitchFamily="18" charset="2"/>
                <a:ea typeface="+mn-ea"/>
                <a:cs typeface="Arial" panose="020B0604020202020204" pitchFamily="34" charset="0"/>
              </a:rPr>
              <a:t>m</a:t>
            </a:r>
            <a:r>
              <a:rPr kumimoji="0" lang="en-US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</a:t>
            </a: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:      0    0    2.5  5   7.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671202" y="181531"/>
            <a:ext cx="981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D-MB03</a:t>
            </a:r>
          </a:p>
        </p:txBody>
      </p:sp>
      <p:cxnSp>
        <p:nvCxnSpPr>
          <p:cNvPr id="26" name="Straight Arrow Connector 25"/>
          <p:cNvCxnSpPr/>
          <p:nvPr/>
        </p:nvCxnSpPr>
        <p:spPr>
          <a:xfrm flipH="1">
            <a:off x="7128389" y="5031918"/>
            <a:ext cx="461387" cy="7881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7589776" y="4918583"/>
            <a:ext cx="11047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Non-specific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70744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0</TotalTime>
  <Words>133</Words>
  <Application>Microsoft Office PowerPoint</Application>
  <PresentationFormat>Widescreen</PresentationFormat>
  <Paragraphs>7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y, Sutapa</dc:creator>
  <cp:lastModifiedBy>Ray, Sutapa</cp:lastModifiedBy>
  <cp:revision>51</cp:revision>
  <dcterms:created xsi:type="dcterms:W3CDTF">2023-02-17T22:03:09Z</dcterms:created>
  <dcterms:modified xsi:type="dcterms:W3CDTF">2023-03-29T23:59:01Z</dcterms:modified>
</cp:coreProperties>
</file>